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5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94" d="100"/>
          <a:sy n="94" d="100"/>
        </p:scale>
        <p:origin x="84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7C047E-50D3-434A-9D13-5FE6CB59C253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AEC668-9392-4B57-8E3E-CF4BFB31159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14967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EED9616-B345-4F49-9291-C0F8B26E37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E9216BB-6B43-4295-A2F7-43C3805F8EB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C25E670-8D09-4196-9B5B-4795C1AFC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F7CB34-1023-4926-BBFB-0C367452E9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D5DFC2-96B5-4744-B43F-AA5F5DC1D1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01386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3F00D18-2067-49F1-AF19-BC5976784A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6E5BC7C-6619-4D62-8C51-933311676B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AFD9AE-8D79-40BA-9CAA-3E467C630A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61242D9-D1C9-44BA-B108-513DC8796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528FBB-A00A-4E4B-92FE-2DA924BD7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626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3B18713-0D2C-4E04-9CC5-8D205C409EF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F3B3784-E7CD-4560-9F98-2B7718CF5B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A9B0D3-374F-4692-8578-85E309EFB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F927CB-E639-4A88-A07B-E6D9AC9F62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9D3ACB-FF06-4E9B-B4D6-C5545E0377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88150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05AA615-96DB-4F51-BDCA-9CB1DC399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C14D1C-081B-4784-9D59-B858C4F1DF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3294B95-E924-48C8-BBD6-DA74117C1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8164FB0-BC85-4020-B57F-08C7CF1E2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FC013CB-ADFF-46BA-B5D3-4F1BEF420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9943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36EFD7-E683-47B2-A504-D8EB2F7CBC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01F0645-63B6-4DA2-BDEB-B33121F530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1365BC-98B6-4820-BE49-7E97FD78E6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8C16F51-EF69-4005-8D34-EA8FA46765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0730611-B2D5-4A54-BD63-12F1218EA9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5567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A6CC14-BC4F-4E36-B3BA-4B0FB65D79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C3BEAD4-0210-4BDC-96DB-BF1CBC320D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34D32C3-5241-4E6F-9CF2-41A89DFB44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5236428-CD29-40CF-97BB-AB494EC18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0D90293-B3EB-4177-922D-E8ECB49B36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EA6FD30-9908-4F10-A60E-8EDDD25FD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249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599FD7-6715-4259-BB17-0BE38783C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B540ADE-E159-4472-AE17-3BF5C6FA57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CE0D9C4-12E8-4FFC-ADFA-74804E813F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1436F04-E430-4B51-8478-6C7505F88E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709BC4E7-88FC-441F-9912-E8E6C00BFC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51CEF2D-D96B-4CE7-9685-7A33203C1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6445E3A-5CAA-4269-839B-B9AC99649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EE748B6-94D0-4D33-9648-0FB17308A4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8772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AD4E6D0-3B1F-4408-9BA2-971CECEC1E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BF239154-8BE9-46F9-9446-C374DD9FBD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9869239-550A-409A-B5EC-FF1DCA59D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36A7201-73EF-4F11-AAA3-CE91ED75AC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4282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9A99916-8CDC-438D-BE74-5B71261C1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5DFAEA4-2CFA-4633-8158-85891CD5C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43D9136-C155-4EF7-BF28-D0099FAF26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81892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2A0063-DEC7-46CA-8446-DF6A7FC833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44D5C27-87EB-4862-8D8C-BEDC61F0EC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61F71C0-29C0-4E02-9BBA-FE5FAABEA7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0FA9C2B-DDD4-40FB-B4F1-E180AB4AB7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142BC62-5AAC-4F0D-92B0-56A17B405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494B74D-75ED-4C30-BA70-C0E8984F0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8232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E8B6C2-D129-4DBA-B792-F9260E8B70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FFEC762-52F8-4111-A1D0-99C0A861F6B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53CA466-7F8C-4CD7-B569-E17CF664FB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5893943-D697-4D09-B93B-681A3BF28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2FB42C-2481-46AC-94F6-28C35A50B1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586C70-16C5-4371-8854-74DA29F18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798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408C736-1E1F-48AE-8BC0-2D1ED9FE02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DC4D8FA-7070-45D1-8253-BBEA83B4EA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28600C-1CDC-4385-8866-14A3A1B301B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8A6D05-96DD-4CC5-9398-641BF891E940}" type="datetimeFigureOut">
              <a:rPr lang="zh-CN" altLang="en-US" smtClean="0"/>
              <a:t>2021/5/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E862CB8-A1A3-4840-B87A-06D10F3566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F30594-3D31-4C68-982C-733BB137D5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E0CBF2-7FD9-45D2-A1E3-0752DD71091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4575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文本框 26">
            <a:extLst>
              <a:ext uri="{FF2B5EF4-FFF2-40B4-BE49-F238E27FC236}">
                <a16:creationId xmlns:a16="http://schemas.microsoft.com/office/drawing/2014/main" id="{91F68F5A-2065-4023-9387-7B67915677D8}"/>
              </a:ext>
            </a:extLst>
          </p:cNvPr>
          <p:cNvSpPr txBox="1"/>
          <p:nvPr/>
        </p:nvSpPr>
        <p:spPr>
          <a:xfrm>
            <a:off x="172938" y="133115"/>
            <a:ext cx="610594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. S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1. Flow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hart  of exercise and diet intervention on DNA methylation of NAFLD in human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5E1C4919-E35B-45B1-B53D-7EAC1A7959DF}"/>
              </a:ext>
            </a:extLst>
          </p:cNvPr>
          <p:cNvSpPr txBox="1"/>
          <p:nvPr/>
        </p:nvSpPr>
        <p:spPr>
          <a:xfrm>
            <a:off x="521836" y="6131212"/>
            <a:ext cx="1014411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aseline="300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1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x, exercise intervention;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LCD, exercise plus low carbohydrate diet;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LCD, low carbohydrate diet; NAFLD, nonalcoholic </a:t>
            </a:r>
            <a:r>
              <a:rPr lang="en-US" altLang="zh-CN" sz="1200" dirty="0">
                <a:latin typeface="Times New Roman" panose="02020603050405020304" pitchFamily="18" charset="0"/>
                <a:ea typeface="宋体" panose="02010600030101010101" pitchFamily="2" charset="-122"/>
              </a:rPr>
              <a:t>fatty liver disease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; </a:t>
            </a:r>
            <a:r>
              <a:rPr lang="en-US" altLang="zh-CN" sz="1200" kern="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o, no intervention.</a:t>
            </a:r>
            <a:endParaRPr lang="zh-CN" altLang="zh-CN" sz="12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B67430D7-0D55-4296-A2D3-B141494EC7C0}"/>
              </a:ext>
            </a:extLst>
          </p:cNvPr>
          <p:cNvGrpSpPr/>
          <p:nvPr/>
        </p:nvGrpSpPr>
        <p:grpSpPr>
          <a:xfrm>
            <a:off x="3025680" y="1008350"/>
            <a:ext cx="4595567" cy="4372213"/>
            <a:chOff x="2707333" y="1279283"/>
            <a:chExt cx="4595567" cy="4372213"/>
          </a:xfrm>
        </p:grpSpPr>
        <p:sp>
          <p:nvSpPr>
            <p:cNvPr id="29" name="Rectangle 297">
              <a:extLst>
                <a:ext uri="{FF2B5EF4-FFF2-40B4-BE49-F238E27FC236}">
                  <a16:creationId xmlns:a16="http://schemas.microsoft.com/office/drawing/2014/main" id="{B3BF5002-8B7C-403E-A2D8-DD7D6C7AE4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8792" y="1279283"/>
              <a:ext cx="3294108" cy="24622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marL="355600" indent="-355600" algn="ctr"/>
              <a:r>
                <a:rPr lang="en-US" altLang="en-US" sz="1000" dirty="0">
                  <a:latin typeface="Times New Roman" pitchFamily="18" charset="0"/>
                  <a:cs typeface="Times New Roman" pitchFamily="18" charset="0"/>
                </a:rPr>
                <a:t>Allocation </a:t>
              </a:r>
              <a:r>
                <a:rPr lang="en-GB" altLang="zh-CN" sz="1000" dirty="0">
                  <a:latin typeface="Times New Roman" pitchFamily="18" charset="0"/>
                  <a:cs typeface="Times New Roman" pitchFamily="18" charset="0"/>
                </a:rPr>
                <a:t>to intervention  (n=115, M</a:t>
              </a:r>
              <a:r>
                <a:rPr lang="en-US" altLang="zh-CN" sz="1000" dirty="0">
                  <a:latin typeface="Times New Roman" pitchFamily="18" charset="0"/>
                  <a:cs typeface="Times New Roman" pitchFamily="18" charset="0"/>
                </a:rPr>
                <a:t>ale/Female,</a:t>
              </a:r>
              <a:r>
                <a:rPr lang="en-GB" altLang="zh-CN" sz="1000" dirty="0">
                  <a:latin typeface="Times New Roman" pitchFamily="18" charset="0"/>
                  <a:cs typeface="Times New Roman" pitchFamily="18" charset="0"/>
                </a:rPr>
                <a:t> age: 50-65) </a:t>
              </a:r>
              <a:endParaRPr lang="en-GB" altLang="zh-CN" sz="1000" dirty="0">
                <a:cs typeface="Times New Roman" pitchFamily="18" charset="0"/>
              </a:endParaRPr>
            </a:p>
          </p:txBody>
        </p:sp>
        <p:cxnSp>
          <p:nvCxnSpPr>
            <p:cNvPr id="30" name="Straight Arrow Connector 2076">
              <a:extLst>
                <a:ext uri="{FF2B5EF4-FFF2-40B4-BE49-F238E27FC236}">
                  <a16:creationId xmlns:a16="http://schemas.microsoft.com/office/drawing/2014/main" id="{E1B8F2E5-7390-44EB-B45E-640DE987F17E}"/>
                </a:ext>
              </a:extLst>
            </p:cNvPr>
            <p:cNvCxnSpPr>
              <a:cxnSpLocks/>
              <a:endCxn id="65" idx="0"/>
            </p:cNvCxnSpPr>
            <p:nvPr/>
          </p:nvCxnSpPr>
          <p:spPr bwMode="auto">
            <a:xfrm>
              <a:off x="4743592" y="1531609"/>
              <a:ext cx="8079" cy="2759436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2076">
              <a:extLst>
                <a:ext uri="{FF2B5EF4-FFF2-40B4-BE49-F238E27FC236}">
                  <a16:creationId xmlns:a16="http://schemas.microsoft.com/office/drawing/2014/main" id="{3F28B514-26FD-489B-907C-C4DCEA860027}"/>
                </a:ext>
              </a:extLst>
            </p:cNvPr>
            <p:cNvCxnSpPr>
              <a:cxnSpLocks/>
              <a:endCxn id="64" idx="0"/>
            </p:cNvCxnSpPr>
            <p:nvPr/>
          </p:nvCxnSpPr>
          <p:spPr bwMode="auto">
            <a:xfrm>
              <a:off x="5894215" y="1521641"/>
              <a:ext cx="9663" cy="2772579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2076">
              <a:extLst>
                <a:ext uri="{FF2B5EF4-FFF2-40B4-BE49-F238E27FC236}">
                  <a16:creationId xmlns:a16="http://schemas.microsoft.com/office/drawing/2014/main" id="{7D6CF270-E013-4D73-B306-7CA95FBCE0AC}"/>
                </a:ext>
              </a:extLst>
            </p:cNvPr>
            <p:cNvCxnSpPr>
              <a:cxnSpLocks/>
              <a:endCxn id="40" idx="0"/>
            </p:cNvCxnSpPr>
            <p:nvPr/>
          </p:nvCxnSpPr>
          <p:spPr bwMode="auto">
            <a:xfrm>
              <a:off x="6453011" y="1521641"/>
              <a:ext cx="14427" cy="276940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 Box 758">
              <a:extLst>
                <a:ext uri="{FF2B5EF4-FFF2-40B4-BE49-F238E27FC236}">
                  <a16:creationId xmlns:a16="http://schemas.microsoft.com/office/drawing/2014/main" id="{D82AB62F-8787-41E7-891F-3278D22D759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97563" y="1714817"/>
              <a:ext cx="539750" cy="75565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o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29 (M=7/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F=22)</a:t>
              </a:r>
            </a:p>
          </p:txBody>
        </p:sp>
        <p:sp>
          <p:nvSpPr>
            <p:cNvPr id="34" name="Text Box 758">
              <a:extLst>
                <a:ext uri="{FF2B5EF4-FFF2-40B4-BE49-F238E27FC236}">
                  <a16:creationId xmlns:a16="http://schemas.microsoft.com/office/drawing/2014/main" id="{B0D68AD7-587E-423E-8F69-DC5F826429D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17447" y="1715814"/>
              <a:ext cx="539750" cy="75565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fi-FI" altLang="zh-CN" sz="1050" dirty="0">
                  <a:latin typeface="Times New Roman" pitchFamily="18" charset="0"/>
                  <a:cs typeface="Times New Roman" pitchFamily="18" charset="0"/>
                </a:rPr>
                <a:t>ELCD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29 (M=7/F=22)</a:t>
              </a:r>
            </a:p>
          </p:txBody>
        </p:sp>
        <p:cxnSp>
          <p:nvCxnSpPr>
            <p:cNvPr id="35" name="Straight Arrow Connector 2076">
              <a:extLst>
                <a:ext uri="{FF2B5EF4-FFF2-40B4-BE49-F238E27FC236}">
                  <a16:creationId xmlns:a16="http://schemas.microsoft.com/office/drawing/2014/main" id="{D49B3806-DBAE-4D9C-907D-D3D525D897D7}"/>
                </a:ext>
              </a:extLst>
            </p:cNvPr>
            <p:cNvCxnSpPr>
              <a:cxnSpLocks/>
              <a:endCxn id="41" idx="0"/>
            </p:cNvCxnSpPr>
            <p:nvPr/>
          </p:nvCxnSpPr>
          <p:spPr bwMode="auto">
            <a:xfrm>
              <a:off x="5333824" y="1521641"/>
              <a:ext cx="6491" cy="2769404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 Box 758">
              <a:extLst>
                <a:ext uri="{FF2B5EF4-FFF2-40B4-BE49-F238E27FC236}">
                  <a16:creationId xmlns:a16="http://schemas.microsoft.com/office/drawing/2014/main" id="{EBCE52CC-282C-4961-ABFD-452FC6ABAA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85559" y="1712639"/>
              <a:ext cx="539750" cy="75565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Ex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29 (M=6/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F=23) </a:t>
              </a:r>
            </a:p>
          </p:txBody>
        </p:sp>
        <p:sp>
          <p:nvSpPr>
            <p:cNvPr id="37" name="Rectangle 297">
              <a:extLst>
                <a:ext uri="{FF2B5EF4-FFF2-40B4-BE49-F238E27FC236}">
                  <a16:creationId xmlns:a16="http://schemas.microsoft.com/office/drawing/2014/main" id="{95CBA4EF-B7B4-467E-A765-9BD5F72A88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5908" y="5235998"/>
              <a:ext cx="2316189" cy="41549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marL="355600" indent="-355600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Extract DNA from blood for DNA methylation analysis</a:t>
              </a:r>
              <a:endParaRPr lang="en-GB" altLang="zh-CN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C1529875-55CF-4B65-B9C3-E5A164BB0ACA}"/>
                </a:ext>
              </a:extLst>
            </p:cNvPr>
            <p:cNvCxnSpPr>
              <a:cxnSpLocks/>
            </p:cNvCxnSpPr>
            <p:nvPr/>
          </p:nvCxnSpPr>
          <p:spPr>
            <a:xfrm>
              <a:off x="4761445" y="4018970"/>
              <a:ext cx="171200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5A3810F8-9557-4525-B4DC-93D0739D36FB}"/>
                </a:ext>
              </a:extLst>
            </p:cNvPr>
            <p:cNvSpPr txBox="1"/>
            <p:nvPr/>
          </p:nvSpPr>
          <p:spPr>
            <a:xfrm>
              <a:off x="2707333" y="3862265"/>
              <a:ext cx="21659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lect on the basis of HFC decline</a:t>
              </a:r>
              <a:endParaRPr lang="zh-CN" altLang="en-US" sz="11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 Box 758">
              <a:extLst>
                <a:ext uri="{FF2B5EF4-FFF2-40B4-BE49-F238E27FC236}">
                  <a16:creationId xmlns:a16="http://schemas.microsoft.com/office/drawing/2014/main" id="{20C4AC25-9AB4-410B-9B13-75C67AA313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197563" y="4291045"/>
              <a:ext cx="539750" cy="41549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o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7 </a:t>
              </a:r>
            </a:p>
          </p:txBody>
        </p:sp>
        <p:sp>
          <p:nvSpPr>
            <p:cNvPr id="41" name="Text Box 758">
              <a:extLst>
                <a:ext uri="{FF2B5EF4-FFF2-40B4-BE49-F238E27FC236}">
                  <a16:creationId xmlns:a16="http://schemas.microsoft.com/office/drawing/2014/main" id="{BC8FA5FD-9F29-4537-8CD3-1F73A0C63A8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70440" y="4291045"/>
              <a:ext cx="539750" cy="41549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LCD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8</a:t>
              </a:r>
            </a:p>
          </p:txBody>
        </p:sp>
        <p:sp>
          <p:nvSpPr>
            <p:cNvPr id="64" name="Text Box 758">
              <a:extLst>
                <a:ext uri="{FF2B5EF4-FFF2-40B4-BE49-F238E27FC236}">
                  <a16:creationId xmlns:a16="http://schemas.microsoft.com/office/drawing/2014/main" id="{ADFC383B-B2F0-448C-8F63-C07F279748B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34003" y="4294220"/>
              <a:ext cx="539750" cy="41549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fi-FI" altLang="zh-CN" sz="1050" dirty="0">
                  <a:latin typeface="Times New Roman" pitchFamily="18" charset="0"/>
                  <a:cs typeface="Times New Roman" pitchFamily="18" charset="0"/>
                </a:rPr>
                <a:t>ELCD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9</a:t>
              </a:r>
            </a:p>
          </p:txBody>
        </p:sp>
        <p:sp>
          <p:nvSpPr>
            <p:cNvPr id="65" name="Text Box 758">
              <a:extLst>
                <a:ext uri="{FF2B5EF4-FFF2-40B4-BE49-F238E27FC236}">
                  <a16:creationId xmlns:a16="http://schemas.microsoft.com/office/drawing/2014/main" id="{873825C3-B01A-494A-AA4B-2B40EFBB8FF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481796" y="4291045"/>
              <a:ext cx="539750" cy="415498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Ex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8</a:t>
              </a:r>
            </a:p>
          </p:txBody>
        </p:sp>
        <p:sp>
          <p:nvSpPr>
            <p:cNvPr id="66" name="Text Box 758">
              <a:extLst>
                <a:ext uri="{FF2B5EF4-FFF2-40B4-BE49-F238E27FC236}">
                  <a16:creationId xmlns:a16="http://schemas.microsoft.com/office/drawing/2014/main" id="{86D517D9-5B01-4CC8-A12D-271EC095E2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53884" y="1712639"/>
              <a:ext cx="539750" cy="75565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LCD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n=28 (M=6/</a:t>
              </a:r>
            </a:p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F=22)</a:t>
              </a:r>
            </a:p>
          </p:txBody>
        </p:sp>
        <p:sp>
          <p:nvSpPr>
            <p:cNvPr id="67" name="Text Box 758">
              <a:extLst>
                <a:ext uri="{FF2B5EF4-FFF2-40B4-BE49-F238E27FC236}">
                  <a16:creationId xmlns:a16="http://schemas.microsoft.com/office/drawing/2014/main" id="{7581D590-CC6F-49CC-9348-2194BC91DCB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311229" y="3173218"/>
              <a:ext cx="2689233" cy="577081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 defTabSz="25400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defTabSz="25400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defTabSz="25400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defTabSz="2540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Dropout in Ex (n=9), LCD (n=7), ELCD (n=9) and No (n=14) groups due to family reasons, health problem, travel and lost interests. </a:t>
              </a:r>
            </a:p>
          </p:txBody>
        </p:sp>
        <p:sp>
          <p:nvSpPr>
            <p:cNvPr id="68" name="Rectangle 297">
              <a:extLst>
                <a:ext uri="{FF2B5EF4-FFF2-40B4-BE49-F238E27FC236}">
                  <a16:creationId xmlns:a16="http://schemas.microsoft.com/office/drawing/2014/main" id="{2D3D0B04-8A85-489E-A1F0-CD1B6E0534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4745" y="2693363"/>
              <a:ext cx="2038516" cy="253916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marL="355600" indent="-355600">
                <a:defRPr/>
              </a:pPr>
              <a:r>
                <a:rPr lang="en-US" altLang="zh-CN" sz="1050" dirty="0">
                  <a:latin typeface="Times New Roman" pitchFamily="18" charset="0"/>
                  <a:cs typeface="Times New Roman" pitchFamily="18" charset="0"/>
                </a:rPr>
                <a:t>         Intervention 6 months</a:t>
              </a:r>
              <a:endParaRPr lang="en-GB" altLang="zh-CN" sz="105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69" name="箭头: 右 68">
              <a:extLst>
                <a:ext uri="{FF2B5EF4-FFF2-40B4-BE49-F238E27FC236}">
                  <a16:creationId xmlns:a16="http://schemas.microsoft.com/office/drawing/2014/main" id="{0FCFE8F1-BCBD-4A12-83E2-92BC5602C833}"/>
                </a:ext>
              </a:extLst>
            </p:cNvPr>
            <p:cNvSpPr/>
            <p:nvPr/>
          </p:nvSpPr>
          <p:spPr>
            <a:xfrm rot="5400000">
              <a:off x="5481964" y="5021432"/>
              <a:ext cx="270533" cy="144592"/>
            </a:xfrm>
            <a:prstGeom prst="rightArrow">
              <a:avLst>
                <a:gd name="adj1" fmla="val 50000"/>
                <a:gd name="adj2" fmla="val 45564"/>
              </a:avLst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70" name="直接连接符 69">
              <a:extLst>
                <a:ext uri="{FF2B5EF4-FFF2-40B4-BE49-F238E27FC236}">
                  <a16:creationId xmlns:a16="http://schemas.microsoft.com/office/drawing/2014/main" id="{6585E973-D21F-4BCD-B019-C665B5EC7F69}"/>
                </a:ext>
              </a:extLst>
            </p:cNvPr>
            <p:cNvCxnSpPr>
              <a:stCxn id="65" idx="2"/>
              <a:endCxn id="69" idx="1"/>
            </p:cNvCxnSpPr>
            <p:nvPr/>
          </p:nvCxnSpPr>
          <p:spPr>
            <a:xfrm>
              <a:off x="4751671" y="4706543"/>
              <a:ext cx="865560" cy="25191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71" name="直接连接符 70">
              <a:extLst>
                <a:ext uri="{FF2B5EF4-FFF2-40B4-BE49-F238E27FC236}">
                  <a16:creationId xmlns:a16="http://schemas.microsoft.com/office/drawing/2014/main" id="{8AB92CF8-2868-4964-B8EC-FC175E6EA29E}"/>
                </a:ext>
              </a:extLst>
            </p:cNvPr>
            <p:cNvCxnSpPr>
              <a:stCxn id="41" idx="2"/>
              <a:endCxn id="69" idx="1"/>
            </p:cNvCxnSpPr>
            <p:nvPr/>
          </p:nvCxnSpPr>
          <p:spPr>
            <a:xfrm>
              <a:off x="5340315" y="4706543"/>
              <a:ext cx="276916" cy="25191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连接符 71">
              <a:extLst>
                <a:ext uri="{FF2B5EF4-FFF2-40B4-BE49-F238E27FC236}">
                  <a16:creationId xmlns:a16="http://schemas.microsoft.com/office/drawing/2014/main" id="{71005CBB-3D01-4631-8CD1-1AD7DB330678}"/>
                </a:ext>
              </a:extLst>
            </p:cNvPr>
            <p:cNvCxnSpPr>
              <a:stCxn id="64" idx="2"/>
              <a:endCxn id="69" idx="1"/>
            </p:cNvCxnSpPr>
            <p:nvPr/>
          </p:nvCxnSpPr>
          <p:spPr>
            <a:xfrm flipH="1">
              <a:off x="5617231" y="4709718"/>
              <a:ext cx="286647" cy="24874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连接符 72">
              <a:extLst>
                <a:ext uri="{FF2B5EF4-FFF2-40B4-BE49-F238E27FC236}">
                  <a16:creationId xmlns:a16="http://schemas.microsoft.com/office/drawing/2014/main" id="{9AAFBF90-5E50-4504-8B82-C9EAF975BFE2}"/>
                </a:ext>
              </a:extLst>
            </p:cNvPr>
            <p:cNvCxnSpPr>
              <a:stCxn id="40" idx="2"/>
              <a:endCxn id="69" idx="1"/>
            </p:cNvCxnSpPr>
            <p:nvPr/>
          </p:nvCxnSpPr>
          <p:spPr>
            <a:xfrm flipH="1">
              <a:off x="5617231" y="4706543"/>
              <a:ext cx="850207" cy="251919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94830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95</Words>
  <Application>Microsoft Office PowerPoint</Application>
  <PresentationFormat>宽屏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ana</dc:creator>
  <cp:lastModifiedBy>Nana</cp:lastModifiedBy>
  <cp:revision>8</cp:revision>
  <dcterms:created xsi:type="dcterms:W3CDTF">2021-04-25T15:28:35Z</dcterms:created>
  <dcterms:modified xsi:type="dcterms:W3CDTF">2021-05-06T05:13:37Z</dcterms:modified>
</cp:coreProperties>
</file>